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3" r:id="rId2"/>
    <p:sldId id="284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14" autoAdjust="0"/>
    <p:restoredTop sz="94660"/>
  </p:normalViewPr>
  <p:slideViewPr>
    <p:cSldViewPr snapToGrid="0" showGuides="1">
      <p:cViewPr>
        <p:scale>
          <a:sx n="96" d="100"/>
          <a:sy n="96" d="100"/>
        </p:scale>
        <p:origin x="-183" y="-2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F05DA5-EE0D-00F2-8472-21576E8FA1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A25E7A3-E231-FB60-FB53-99EDC149E5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B13CC2-A4B7-5FE3-08EA-478A333F0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ACEA27-A24E-7FEF-0BEB-B0FBD353F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52C42E-8737-8894-7D87-0D68BD71A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411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038526-A0C9-277C-DF94-9DA010C4CD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DACC374-7B5A-DED4-2AFC-2040FB8967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66EBC6-B074-A7AC-5035-077396C4A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4EB63C-D9B5-F8FC-EDDC-A2879DB13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57A00C-B4BF-DD8C-A9E8-1E84B9B78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467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09D1066-C480-A63E-CB5E-B77FB60D2B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3ABDD7B-CAD1-9B5E-D480-2AEBCD2AF7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DE13B6-61CA-81C8-480F-14FBC17D0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F61D5F-9FB6-D498-74B0-79CF5600E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16AF50-9396-70EB-9BCF-03037F4C6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529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E4CBB8-73A0-05FC-65CF-F553F2BA8D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56B3CA-F59F-4152-87F8-458ADC65FF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BA26E9-41F4-9F94-D854-73264144D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9FC70F-8743-3FCD-7184-F9CDF0238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4E8893-B520-4347-0EED-96DD8DD8C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4016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5855AA-AE00-76B1-7622-48C078E8C9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34AD1A-A17A-F8CD-7778-E475BD8135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06B206-5649-93B3-2557-14593CBBD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0CDE54-72EF-EFD7-7906-DAC405E8D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C4C40A-A933-1949-CE87-8B1008357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834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67F18D-2C5F-43BE-482D-77AC744917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14FDFF9-2857-D321-D5F6-B974A7B8AA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CAB415-2746-FD40-7C5F-CC1B81BF09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77889B-0CAD-7C7E-D8BA-5759B757C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561553-9F42-2FA7-CB7D-4ECDC24D7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E06B4A-583C-A4E1-0F24-C5DE97215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8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A8B538-D387-E425-0886-4F94969D3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093F0D-0418-3372-4BD2-26AA63C475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635CED-8CF7-446F-A13A-E56DCBC213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CA1DF8B-1373-3FDE-7BBE-6ADF1D7A3C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16E8D13-DF53-6020-E875-20C897E895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305176A-2301-7621-8C76-1FBEE7CC8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A539CF7-22D9-6C2D-FB51-6EF379255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A445822-684D-0128-EB53-87286BD17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4530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E9C7C8-0A72-25C9-FE34-6FD2EE3A73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0B67C33-7DA4-EA7B-905C-8AE3C0072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56A8B3F-15E6-5AE0-C781-BFFB66CE5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0CA3FA2-E9C8-5D39-E264-BF3EEFC58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904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81C7B83-1EB7-7D31-9066-5F4AF39B0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8D6FEDF-D2AE-9DD1-73D4-36738492C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2FE9447-2476-9770-A40D-34EE2E248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866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785C63-D29B-8CF3-8CE5-EA67AE656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8F025B-7D3A-8C9A-93F7-28A678C07D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3B40C1-E7F5-AD33-987F-BA44EC5D3E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B8694F-2746-022A-65FC-349B1C8C7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E7F477-E9CE-A913-0247-8B98BEE60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35C9E-24DB-8AB6-2E54-1B6F614F6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217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EB4984-A990-FFF2-E62F-24528D3482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F7F6055-A4C0-C389-1E9A-BA55E81579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14924D-9E3D-2FBF-83A6-F91D95F66C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38ABEE-E6C2-B302-672F-DD3C9AD85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296FD3-D65D-18FC-4B14-3A08EEB94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EA09CF-5867-17C8-CC6E-AB54D245F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047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27A7C14-BE6D-538D-BFB1-2A8861E10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BA710EF-2912-B9BD-A4B5-475ABB47D8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EF0B93-97A5-5B81-6CFE-4A86611959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7F2449-2904-45A6-9094-B3C935EEDD20}" type="datetimeFigureOut">
              <a:rPr lang="zh-CN" altLang="en-US" smtClean="0"/>
              <a:t>2026/4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8449F7-B7BF-B0E6-6303-D13EC86221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A32E27-85DA-96B1-9C61-A61213A8A7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AF37D4-9FF9-4CB2-A60D-20497E42E0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390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7BAD8B76-203E-4B4A-9E9A-EBFF97F47A62}"/>
              </a:ext>
            </a:extLst>
          </p:cNvPr>
          <p:cNvSpPr/>
          <p:nvPr/>
        </p:nvSpPr>
        <p:spPr>
          <a:xfrm>
            <a:off x="305491" y="6267868"/>
            <a:ext cx="11495445" cy="246221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ghted gene co-expressed network were built by 36,294 genes. Scale independence and mean connectivity (A); gene cluster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dogram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odules (B). Correlation relation was set 0.8 and β was 8.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A9D77F7-457B-9BCE-44F9-E032820105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6103" y="224677"/>
            <a:ext cx="9500558" cy="313033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ABC1A76-FC07-6C1D-81C9-C20C575637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6359" y="3078011"/>
            <a:ext cx="9381454" cy="309108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44DA98C-75BC-44A5-B7C1-FDE68589E65F}"/>
              </a:ext>
            </a:extLst>
          </p:cNvPr>
          <p:cNvSpPr txBox="1"/>
          <p:nvPr/>
        </p:nvSpPr>
        <p:spPr>
          <a:xfrm>
            <a:off x="933933" y="412442"/>
            <a:ext cx="2524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92A9E31-050F-45E7-A3CC-E132712A8278}"/>
              </a:ext>
            </a:extLst>
          </p:cNvPr>
          <p:cNvSpPr txBox="1"/>
          <p:nvPr/>
        </p:nvSpPr>
        <p:spPr>
          <a:xfrm>
            <a:off x="893676" y="3602299"/>
            <a:ext cx="2524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86231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>
            <a:extLst>
              <a:ext uri="{FF2B5EF4-FFF2-40B4-BE49-F238E27FC236}">
                <a16:creationId xmlns:a16="http://schemas.microsoft.com/office/drawing/2014/main" id="{A1D5105E-294B-4314-9E5D-871DB71228E6}"/>
              </a:ext>
            </a:extLst>
          </p:cNvPr>
          <p:cNvSpPr/>
          <p:nvPr/>
        </p:nvSpPr>
        <p:spPr>
          <a:xfrm>
            <a:off x="3941936" y="5250511"/>
            <a:ext cx="43081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analysis (A) and correlation relationship (B) of 33 modules. 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C0C29FD-DD69-9C55-97C0-8FB4DF21F5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82771"/>
            <a:ext cx="12192000" cy="401713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0FCD50B-A34D-4765-833B-D37EE5E7A8EE}"/>
              </a:ext>
            </a:extLst>
          </p:cNvPr>
          <p:cNvSpPr txBox="1"/>
          <p:nvPr/>
        </p:nvSpPr>
        <p:spPr>
          <a:xfrm>
            <a:off x="-68425" y="3152001"/>
            <a:ext cx="2524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C200E13-1888-4686-9AA1-495C0FFBBEC5}"/>
              </a:ext>
            </a:extLst>
          </p:cNvPr>
          <p:cNvSpPr txBox="1"/>
          <p:nvPr/>
        </p:nvSpPr>
        <p:spPr>
          <a:xfrm>
            <a:off x="-68424" y="1204097"/>
            <a:ext cx="2524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2065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</TotalTime>
  <Words>61</Words>
  <Application>Microsoft Office PowerPoint</Application>
  <PresentationFormat>宽屏</PresentationFormat>
  <Paragraphs>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艳 石</dc:creator>
  <cp:lastModifiedBy>艳 石</cp:lastModifiedBy>
  <cp:revision>3</cp:revision>
  <dcterms:created xsi:type="dcterms:W3CDTF">2026-04-13T08:19:39Z</dcterms:created>
  <dcterms:modified xsi:type="dcterms:W3CDTF">2026-04-13T12:39:22Z</dcterms:modified>
</cp:coreProperties>
</file>